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ppt/charts/chart1.xml" ContentType="application/vnd.openxmlformats-officedocument.drawingml.char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7099300" cy="10234613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86" d="100"/>
          <a:sy n="86" d="100"/>
        </p:scale>
        <p:origin x="-1542" y="-90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Documents%20and%20Settings\csic\Mis%20documentos\ICVV%20Manolo\My%20Dropbox\Paper%20HIP%20HOP\Figuras%20individuales\Figuras%20HIP%20(1A,%201B,%20S2,%205A,%204A,%204B,%205C)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es-ES_tradnl"/>
  <c:chart>
    <c:plotArea>
      <c:layout>
        <c:manualLayout>
          <c:layoutTarget val="inner"/>
          <c:xMode val="edge"/>
          <c:yMode val="edge"/>
          <c:x val="0.12798955495014552"/>
          <c:y val="4.4858679665530886E-2"/>
          <c:w val="0.7602706313651747"/>
          <c:h val="0.69763677051756223"/>
        </c:manualLayout>
      </c:layout>
      <c:barChart>
        <c:barDir val="col"/>
        <c:grouping val="clustered"/>
        <c:ser>
          <c:idx val="0"/>
          <c:order val="0"/>
          <c:tx>
            <c:v>24 h</c:v>
          </c:tx>
          <c:spPr>
            <a:solidFill>
              <a:schemeClr val="bg1"/>
            </a:solidFill>
            <a:ln>
              <a:solidFill>
                <a:schemeClr val="tx1"/>
              </a:solidFill>
            </a:ln>
          </c:spPr>
          <c:cat>
            <c:strRef>
              <c:f>Sheet1!$D$13:$D$19</c:f>
              <c:strCache>
                <c:ptCount val="7"/>
                <c:pt idx="0">
                  <c:v>PGS1</c:v>
                </c:pt>
                <c:pt idx="1">
                  <c:v>RNQ1</c:v>
                </c:pt>
                <c:pt idx="2">
                  <c:v>YHR086W-A</c:v>
                </c:pt>
                <c:pt idx="3">
                  <c:v>YPL102C</c:v>
                </c:pt>
                <c:pt idx="4">
                  <c:v>FMP30</c:v>
                </c:pt>
                <c:pt idx="5">
                  <c:v>DAP1</c:v>
                </c:pt>
                <c:pt idx="6">
                  <c:v>RBD2</c:v>
                </c:pt>
              </c:strCache>
            </c:strRef>
          </c:cat>
          <c:val>
            <c:numRef>
              <c:f>Sheet1!$E$13:$E$19</c:f>
              <c:numCache>
                <c:formatCode>0.00</c:formatCode>
                <c:ptCount val="7"/>
                <c:pt idx="0">
                  <c:v>0.95165745856353789</c:v>
                </c:pt>
                <c:pt idx="1">
                  <c:v>0.89502762430939375</c:v>
                </c:pt>
                <c:pt idx="2">
                  <c:v>0.92679558011049823</c:v>
                </c:pt>
                <c:pt idx="3">
                  <c:v>0.87845303867403424</c:v>
                </c:pt>
                <c:pt idx="4">
                  <c:v>0.8577348066298367</c:v>
                </c:pt>
                <c:pt idx="5">
                  <c:v>0.90193370165745756</c:v>
                </c:pt>
                <c:pt idx="6">
                  <c:v>0.83011049723756902</c:v>
                </c:pt>
              </c:numCache>
            </c:numRef>
          </c:val>
        </c:ser>
        <c:ser>
          <c:idx val="1"/>
          <c:order val="1"/>
          <c:tx>
            <c:v>21 days</c:v>
          </c:tx>
          <c:spPr>
            <a:solidFill>
              <a:schemeClr val="tx1"/>
            </a:solidFill>
          </c:spPr>
          <c:cat>
            <c:strRef>
              <c:f>Sheet1!$D$13:$D$19</c:f>
              <c:strCache>
                <c:ptCount val="7"/>
                <c:pt idx="0">
                  <c:v>PGS1</c:v>
                </c:pt>
                <c:pt idx="1">
                  <c:v>RNQ1</c:v>
                </c:pt>
                <c:pt idx="2">
                  <c:v>YHR086W-A</c:v>
                </c:pt>
                <c:pt idx="3">
                  <c:v>YPL102C</c:v>
                </c:pt>
                <c:pt idx="4">
                  <c:v>FMP30</c:v>
                </c:pt>
                <c:pt idx="5">
                  <c:v>DAP1</c:v>
                </c:pt>
                <c:pt idx="6">
                  <c:v>RBD2</c:v>
                </c:pt>
              </c:strCache>
            </c:strRef>
          </c:cat>
          <c:val>
            <c:numRef>
              <c:f>Sheet1!$F$13:$F$19</c:f>
              <c:numCache>
                <c:formatCode>0.00</c:formatCode>
                <c:ptCount val="7"/>
                <c:pt idx="0">
                  <c:v>1.002147458840372</c:v>
                </c:pt>
                <c:pt idx="1">
                  <c:v>0.92770221904080175</c:v>
                </c:pt>
                <c:pt idx="2">
                  <c:v>0.88188976377952821</c:v>
                </c:pt>
                <c:pt idx="3">
                  <c:v>1.0450966356478146</c:v>
                </c:pt>
                <c:pt idx="4">
                  <c:v>1.0071581961345739</c:v>
                </c:pt>
                <c:pt idx="5">
                  <c:v>0.91481746599856828</c:v>
                </c:pt>
                <c:pt idx="6">
                  <c:v>0.99642090193271138</c:v>
                </c:pt>
              </c:numCache>
            </c:numRef>
          </c:val>
        </c:ser>
        <c:axId val="74315648"/>
        <c:axId val="74317184"/>
      </c:barChart>
      <c:catAx>
        <c:axId val="74315648"/>
        <c:scaling>
          <c:orientation val="minMax"/>
        </c:scaling>
        <c:axPos val="b"/>
        <c:tickLblPos val="nextTo"/>
        <c:txPr>
          <a:bodyPr/>
          <a:lstStyle/>
          <a:p>
            <a:pPr>
              <a:defRPr sz="1100">
                <a:latin typeface="Arial" pitchFamily="34" charset="0"/>
                <a:cs typeface="Arial" pitchFamily="34" charset="0"/>
              </a:defRPr>
            </a:pPr>
            <a:endParaRPr lang="es-ES_tradnl"/>
          </a:p>
        </c:txPr>
        <c:crossAx val="74317184"/>
        <c:crosses val="autoZero"/>
        <c:auto val="1"/>
        <c:lblAlgn val="ctr"/>
        <c:lblOffset val="100"/>
      </c:catAx>
      <c:valAx>
        <c:axId val="74317184"/>
        <c:scaling>
          <c:orientation val="minMax"/>
        </c:scaling>
        <c:axPos val="l"/>
        <c:majorGridlines/>
        <c:title>
          <c:tx>
            <c:rich>
              <a:bodyPr rot="-5400000" vert="horz"/>
              <a:lstStyle/>
              <a:p>
                <a:pPr>
                  <a:defRPr sz="1200">
                    <a:latin typeface="Arial" pitchFamily="34" charset="0"/>
                    <a:cs typeface="Arial" pitchFamily="34" charset="0"/>
                  </a:defRPr>
                </a:pPr>
                <a:r>
                  <a:rPr lang="es-ES" sz="1200" dirty="0" err="1">
                    <a:latin typeface="Arial" pitchFamily="34" charset="0"/>
                    <a:cs typeface="Arial" pitchFamily="34" charset="0"/>
                  </a:rPr>
                  <a:t>Relative</a:t>
                </a:r>
                <a:r>
                  <a:rPr lang="es-ES" sz="1200" baseline="0" dirty="0">
                    <a:latin typeface="Arial" pitchFamily="34" charset="0"/>
                    <a:cs typeface="Arial" pitchFamily="34" charset="0"/>
                  </a:rPr>
                  <a:t> </a:t>
                </a:r>
                <a:r>
                  <a:rPr lang="es-ES" sz="1200" baseline="0" dirty="0" err="1" smtClean="0">
                    <a:latin typeface="Arial" pitchFamily="34" charset="0"/>
                    <a:cs typeface="Arial" pitchFamily="34" charset="0"/>
                  </a:rPr>
                  <a:t>biomass</a:t>
                </a:r>
                <a:endParaRPr lang="es-ES" sz="1200" dirty="0">
                  <a:latin typeface="Arial" pitchFamily="34" charset="0"/>
                  <a:cs typeface="Arial" pitchFamily="34" charset="0"/>
                </a:endParaRPr>
              </a:p>
            </c:rich>
          </c:tx>
          <c:layout>
            <c:manualLayout>
              <c:xMode val="edge"/>
              <c:yMode val="edge"/>
              <c:x val="8.3985395799363802E-3"/>
              <c:y val="0.18858788932748996"/>
            </c:manualLayout>
          </c:layout>
        </c:title>
        <c:numFmt formatCode="0.0" sourceLinked="0"/>
        <c:tickLblPos val="nextTo"/>
        <c:txPr>
          <a:bodyPr/>
          <a:lstStyle/>
          <a:p>
            <a:pPr>
              <a:defRPr>
                <a:latin typeface="Arial" pitchFamily="34" charset="0"/>
                <a:cs typeface="Arial" pitchFamily="34" charset="0"/>
              </a:defRPr>
            </a:pPr>
            <a:endParaRPr lang="es-ES_tradnl"/>
          </a:p>
        </c:txPr>
        <c:crossAx val="74315648"/>
        <c:crosses val="autoZero"/>
        <c:crossBetween val="between"/>
      </c:valAx>
    </c:plotArea>
    <c:plotVisOnly val="1"/>
  </c:chart>
  <c:spPr>
    <a:solidFill>
      <a:schemeClr val="bg1"/>
    </a:solidFill>
    <a:ln>
      <a:noFill/>
    </a:ln>
  </c:spPr>
  <c:externalData r:id="rId1"/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8B0029-4863-41E0-B0FC-C670E1B5A6F7}" type="datetimeFigureOut">
              <a:rPr lang="en-US" smtClean="0"/>
              <a:pPr/>
              <a:t>6/23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714F99-2973-473B-8493-EF09FC15F521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8B0029-4863-41E0-B0FC-C670E1B5A6F7}" type="datetimeFigureOut">
              <a:rPr lang="en-US" smtClean="0"/>
              <a:pPr/>
              <a:t>6/23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714F99-2973-473B-8493-EF09FC15F521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8B0029-4863-41E0-B0FC-C670E1B5A6F7}" type="datetimeFigureOut">
              <a:rPr lang="en-US" smtClean="0"/>
              <a:pPr/>
              <a:t>6/23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714F99-2973-473B-8493-EF09FC15F521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8B0029-4863-41E0-B0FC-C670E1B5A6F7}" type="datetimeFigureOut">
              <a:rPr lang="en-US" smtClean="0"/>
              <a:pPr/>
              <a:t>6/23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714F99-2973-473B-8493-EF09FC15F521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8B0029-4863-41E0-B0FC-C670E1B5A6F7}" type="datetimeFigureOut">
              <a:rPr lang="en-US" smtClean="0"/>
              <a:pPr/>
              <a:t>6/23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714F99-2973-473B-8493-EF09FC15F521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8B0029-4863-41E0-B0FC-C670E1B5A6F7}" type="datetimeFigureOut">
              <a:rPr lang="en-US" smtClean="0"/>
              <a:pPr/>
              <a:t>6/23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714F99-2973-473B-8493-EF09FC15F521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8B0029-4863-41E0-B0FC-C670E1B5A6F7}" type="datetimeFigureOut">
              <a:rPr lang="en-US" smtClean="0"/>
              <a:pPr/>
              <a:t>6/23/201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714F99-2973-473B-8493-EF09FC15F521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8B0029-4863-41E0-B0FC-C670E1B5A6F7}" type="datetimeFigureOut">
              <a:rPr lang="en-US" smtClean="0"/>
              <a:pPr/>
              <a:t>6/23/201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714F99-2973-473B-8493-EF09FC15F521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8B0029-4863-41E0-B0FC-C670E1B5A6F7}" type="datetimeFigureOut">
              <a:rPr lang="en-US" smtClean="0"/>
              <a:pPr/>
              <a:t>6/23/201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714F99-2973-473B-8493-EF09FC15F521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8B0029-4863-41E0-B0FC-C670E1B5A6F7}" type="datetimeFigureOut">
              <a:rPr lang="en-US" smtClean="0"/>
              <a:pPr/>
              <a:t>6/23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714F99-2973-473B-8493-EF09FC15F521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8B0029-4863-41E0-B0FC-C670E1B5A6F7}" type="datetimeFigureOut">
              <a:rPr lang="en-US" smtClean="0"/>
              <a:pPr/>
              <a:t>6/23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714F99-2973-473B-8493-EF09FC15F521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38B0029-4863-41E0-B0FC-C670E1B5A6F7}" type="datetimeFigureOut">
              <a:rPr lang="en-US" smtClean="0"/>
              <a:pPr/>
              <a:t>6/23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7714F99-2973-473B-8493-EF09FC15F521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15 Gráfico"/>
          <p:cNvGraphicFramePr/>
          <p:nvPr/>
        </p:nvGraphicFramePr>
        <p:xfrm>
          <a:off x="2267744" y="908720"/>
          <a:ext cx="4536503" cy="352839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3" name="Rectangle 2"/>
          <p:cNvSpPr/>
          <p:nvPr/>
        </p:nvSpPr>
        <p:spPr>
          <a:xfrm>
            <a:off x="1043608" y="4509120"/>
            <a:ext cx="7632848" cy="203132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fontAlgn="base">
              <a:lnSpc>
                <a:spcPct val="150000"/>
              </a:lnSpc>
            </a:pPr>
            <a:r>
              <a:rPr lang="en-US" sz="1200" b="1" dirty="0" smtClean="0">
                <a:latin typeface="Arial"/>
              </a:rPr>
              <a:t>Figure S2: </a:t>
            </a:r>
            <a:r>
              <a:rPr lang="en-US" sz="1200" dirty="0" smtClean="0">
                <a:latin typeface="Arial"/>
              </a:rPr>
              <a:t>Relative biomass observed after 24 h (white bars) or after fermentation arrest (black bars) for strains identified simultaneously under Phase I and Phase II conditions by HIP analyses. Relative biomass after 24 h was estimated by comparing turbidity of the indicated strains with the control strain (BY4743) in the same batch. It was measured as NTUs with a 2100N </a:t>
            </a:r>
            <a:r>
              <a:rPr lang="en-US" sz="1200" dirty="0" err="1" smtClean="0">
                <a:latin typeface="Arial"/>
              </a:rPr>
              <a:t>Turbidimeter</a:t>
            </a:r>
            <a:r>
              <a:rPr lang="en-US" sz="1200" dirty="0" smtClean="0">
                <a:latin typeface="Arial"/>
              </a:rPr>
              <a:t> (HASH, Loveland. CO). Relative biomass after 21 days was estimated by measuring OD600 of the </a:t>
            </a:r>
            <a:r>
              <a:rPr lang="en-US" sz="1200" smtClean="0">
                <a:latin typeface="Arial"/>
              </a:rPr>
              <a:t>homogenized </a:t>
            </a:r>
            <a:r>
              <a:rPr lang="en-US" sz="1200" smtClean="0">
                <a:latin typeface="Arial"/>
              </a:rPr>
              <a:t>culture and </a:t>
            </a:r>
            <a:r>
              <a:rPr lang="en-US" sz="1200" dirty="0" smtClean="0">
                <a:latin typeface="Arial"/>
              </a:rPr>
              <a:t>comparing data </a:t>
            </a:r>
            <a:r>
              <a:rPr lang="en-US" sz="1200" dirty="0" smtClean="0">
                <a:latin typeface="Arial"/>
              </a:rPr>
              <a:t>from the </a:t>
            </a:r>
            <a:r>
              <a:rPr lang="en-US" sz="1200" dirty="0" smtClean="0">
                <a:latin typeface="Arial"/>
              </a:rPr>
              <a:t>deleted strains with those of the control strain (BY4743) in the same batch. No statistically significant differences were found between BY4743 and the deleted strain.</a:t>
            </a:r>
            <a:endParaRPr lang="en-US" sz="2400" b="1" dirty="0">
              <a:latin typeface="Times New Roman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7</TotalTime>
  <Words>128</Words>
  <Application>Microsoft Office PowerPoint</Application>
  <PresentationFormat>On-screen Show (4:3)</PresentationFormat>
  <Paragraphs>2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Company/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csic</dc:creator>
  <cp:lastModifiedBy>Pilar y Ramón</cp:lastModifiedBy>
  <cp:revision>10</cp:revision>
  <dcterms:created xsi:type="dcterms:W3CDTF">2013-03-12T09:37:10Z</dcterms:created>
  <dcterms:modified xsi:type="dcterms:W3CDTF">2013-06-23T09:27:37Z</dcterms:modified>
</cp:coreProperties>
</file>